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80" d="100"/>
          <a:sy n="80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085F22-D701-52B7-8ABC-C97C46ABD54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9EE7AC5C-954C-68FE-A5DE-5469DA561A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784979E-AF7E-1752-4E9C-0E17F42FEE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E9FBF1-348E-13E4-E0C5-94EC266A95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01CAD56-5BD2-1A0D-9092-DCD7AE266C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0153297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89F2F14-3903-74A9-B9D1-090071D8D5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60217A2-D5F2-4924-BEFC-E71A2297ED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825B84-F173-AB59-4DA9-0D0FD95DF0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D0D3704-BDE3-A85C-3F69-B64FDFF52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FD799F-D07A-ADD2-DE71-E9F7C2458D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442875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942E545-D6A0-AC28-7389-11D92621FB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49023B5-9A95-E4D2-253A-26F6EEDF488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8D3EB84-3950-248B-B11D-71A2903F3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4968F49-138B-9B43-63E8-508B9747B2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0B4367-252E-3F8E-5B1B-34BFF85FA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845374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257A546-CD1A-3D99-A065-A29FE9228F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63B9E2D-1BDA-06C4-A8D8-D1EF5BDC3A0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F2EA18-C18C-2375-DE79-8B8C030BB9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5EF4068-AF8B-2917-EBA3-68C9A92459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FB03A50-02D2-C108-011A-6E051C9B8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597637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59008FE-BA7F-B833-98D7-ADD97C2AE4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C37658-0B1F-0803-F7E0-F5F15D3872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0008105-A067-EAD9-0E3B-182E494CDE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D54DD2A-8AE8-3CE0-987C-6FC51FD208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7BD2D36-1759-0E6E-34B1-F38DB4008A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8342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D5033D-BFD4-D107-03E1-29DBEF760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A03F30-7661-DDBF-C0DF-855B2234FB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9825057-E38A-61EB-DEB7-39A7F4C276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BB1945-598B-9A39-1EAB-D0D84F4A7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73DAF84-D3B4-FAA9-AC66-AD53DC7CB2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CFB185E6-AAF1-37E5-B52F-FB692077FC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847742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A0408C-18CE-876C-B150-1474BA330D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319AD9E-7CBB-5A50-889C-5D49370C02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310BE3F-EFF9-BAEE-ACC0-1601422971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008E48C-A466-75F1-F910-2704D5BBC29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61D2136-714B-34EA-B1D8-C2A815CA84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42D1260-103E-C0F9-21E1-6C562027F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BA82CF3-F200-FD32-B855-BBF701559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13B78720-D79A-3DAA-5D2B-9FBB6CF480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88271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A8981F-1793-9228-32C1-0DC7E27A8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6F3F913C-2AFA-B22F-867C-5A0F785654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1100F16-C5E4-1B02-ABAA-13E425F4AF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079DB3C-02A8-AFB1-A5DA-A00AD236A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660899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2DE4F3D-2A85-5A05-89B1-D4BBC501F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721C38F-5455-D68A-2B39-DC3372E11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C091E07-B47F-F782-C3FE-B165322CAD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4056258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D3E0FF-5473-39B3-CF28-AF343A5AA6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820CAE4-F471-A55D-05C6-71C6A4C3F7D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F8AC4DC-7F62-14BC-1E55-5BFC8896A1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7DE60A2-2439-B8D9-3A5F-4948079A5E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417A90E-560F-3C65-F18A-D0B816458B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AC973CF-7F2E-EA58-238D-A6FED0A8A8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7021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044B5E-F45B-E2A6-5D91-1690E90A2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E043126-E1AA-35A4-CEE6-7BDA0C8577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064F474-F526-CBDA-0ADC-A2FD0B5830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96A421C-30E3-70B1-4BDC-BCC24C996B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A661048-5B0C-A75D-16CC-0801922E2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B7C7CB2-EF68-CE6A-AC26-6BF859F1E6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38302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5E391198-70CA-2461-CE2A-3A106A85B6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FE6F73A-33BF-CFD1-A041-79FC3AC831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793B05C-C89C-58B1-23FF-7511DE0F99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44908D-3E56-9247-B4C5-7C4B877929B3}" type="datetimeFigureOut">
              <a:rPr kumimoji="1" lang="zh-CN" altLang="en-US" smtClean="0"/>
              <a:t>2025/9/29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4E8E4DE-55C9-2290-3322-0557D719CBB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24905A1-0E2A-6F69-8A52-E0BD31197E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89ABD8B6-2DB2-234E-B1DC-B4A39AA42577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383759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图片包含 形状&#10;&#10;AI 生成的内容可能不正确。">
            <a:extLst>
              <a:ext uri="{FF2B5EF4-FFF2-40B4-BE49-F238E27FC236}">
                <a16:creationId xmlns:a16="http://schemas.microsoft.com/office/drawing/2014/main" id="{036E378E-F0C0-099F-BA94-F147A1BB5F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30618" y="165506"/>
            <a:ext cx="7772400" cy="608555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CA95C5D-3BAB-0411-0A67-8C337B2A1D13}"/>
              </a:ext>
            </a:extLst>
          </p:cNvPr>
          <p:cNvSpPr txBox="1"/>
          <p:nvPr/>
        </p:nvSpPr>
        <p:spPr>
          <a:xfrm>
            <a:off x="977462" y="6211669"/>
            <a:ext cx="7252137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zh-CN" sz="1800" b="1" kern="1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quence logo conserved motif </a:t>
            </a:r>
            <a:r>
              <a:rPr lang="en-US" altLang="zh-CN" kern="1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kern="100" dirty="0" err="1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ErCE</a:t>
            </a:r>
            <a:r>
              <a:rPr lang="en-US" altLang="zh-CN" kern="100" dirty="0">
                <a:solidFill>
                  <a:srgbClr val="000000"/>
                </a:solidFill>
                <a:latin typeface="Palatino Linotype" panose="0204050205050503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800" kern="1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teins.</a:t>
            </a:r>
            <a:endParaRPr lang="zh-CN" altLang="zh-CN" sz="1800" kern="100" dirty="0">
              <a:solidFill>
                <a:srgbClr val="000000"/>
              </a:solidFill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438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表, 直方图&#10;&#10;AI 生成的内容可能不正确。">
            <a:extLst>
              <a:ext uri="{FF2B5EF4-FFF2-40B4-BE49-F238E27FC236}">
                <a16:creationId xmlns:a16="http://schemas.microsoft.com/office/drawing/2014/main" id="{7BA86AD1-1E5D-96D5-BDB9-D09AB533BA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87836" y="928195"/>
            <a:ext cx="7772400" cy="4678655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8B244501-460B-991B-88D4-36F3D14114BC}"/>
              </a:ext>
            </a:extLst>
          </p:cNvPr>
          <p:cNvSpPr txBox="1"/>
          <p:nvPr/>
        </p:nvSpPr>
        <p:spPr>
          <a:xfrm>
            <a:off x="1800734" y="6089355"/>
            <a:ext cx="834660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The numbers of predicted CAREs in the </a:t>
            </a:r>
            <a:r>
              <a:rPr lang="en-US" altLang="zh-CN" i="1" kern="1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r</a:t>
            </a:r>
            <a:r>
              <a:rPr lang="en-US" altLang="zh-CN" sz="18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</a:t>
            </a:r>
            <a:r>
              <a:rPr lang="en-US" altLang="zh-CN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romoter regions. </a:t>
            </a:r>
            <a:endParaRPr lang="zh-CN" altLang="en-US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383620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5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Palatino Linotype</vt:lpstr>
      <vt:lpstr>Times New Roman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463</dc:creator>
  <cp:lastModifiedBy>Yafei Wang</cp:lastModifiedBy>
  <cp:revision>5</cp:revision>
  <dcterms:created xsi:type="dcterms:W3CDTF">2025-07-22T12:09:04Z</dcterms:created>
  <dcterms:modified xsi:type="dcterms:W3CDTF">2025-09-29T12:25:25Z</dcterms:modified>
</cp:coreProperties>
</file>